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30267275" cy="427942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479" userDrawn="1">
          <p15:clr>
            <a:srgbClr val="A4A3A4"/>
          </p15:clr>
        </p15:guide>
        <p15:guide id="2" pos="953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49" autoAdjust="0"/>
    <p:restoredTop sz="94660"/>
  </p:normalViewPr>
  <p:slideViewPr>
    <p:cSldViewPr snapToGrid="0" showGuides="1">
      <p:cViewPr varScale="1">
        <p:scale>
          <a:sx n="14" d="100"/>
          <a:sy n="14" d="100"/>
        </p:scale>
        <p:origin x="2491" y="115"/>
      </p:cViewPr>
      <p:guideLst>
        <p:guide orient="horz" pos="13479"/>
        <p:guide pos="953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0046" y="7003597"/>
            <a:ext cx="25727184" cy="14898735"/>
          </a:xfrm>
        </p:spPr>
        <p:txBody>
          <a:bodyPr anchor="b"/>
          <a:lstStyle>
            <a:lvl1pPr algn="ctr">
              <a:defRPr sz="198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3410" y="22476884"/>
            <a:ext cx="22700456" cy="10332032"/>
          </a:xfrm>
        </p:spPr>
        <p:txBody>
          <a:bodyPr/>
          <a:lstStyle>
            <a:lvl1pPr marL="0" indent="0" algn="ctr">
              <a:buNone/>
              <a:defRPr sz="7944"/>
            </a:lvl1pPr>
            <a:lvl2pPr marL="1513378" indent="0" algn="ctr">
              <a:buNone/>
              <a:defRPr sz="6620"/>
            </a:lvl2pPr>
            <a:lvl3pPr marL="3026755" indent="0" algn="ctr">
              <a:buNone/>
              <a:defRPr sz="5958"/>
            </a:lvl3pPr>
            <a:lvl4pPr marL="4540133" indent="0" algn="ctr">
              <a:buNone/>
              <a:defRPr sz="5296"/>
            </a:lvl4pPr>
            <a:lvl5pPr marL="6053511" indent="0" algn="ctr">
              <a:buNone/>
              <a:defRPr sz="5296"/>
            </a:lvl5pPr>
            <a:lvl6pPr marL="7566889" indent="0" algn="ctr">
              <a:buNone/>
              <a:defRPr sz="5296"/>
            </a:lvl6pPr>
            <a:lvl7pPr marL="9080266" indent="0" algn="ctr">
              <a:buNone/>
              <a:defRPr sz="5296"/>
            </a:lvl7pPr>
            <a:lvl8pPr marL="10593644" indent="0" algn="ctr">
              <a:buNone/>
              <a:defRPr sz="5296"/>
            </a:lvl8pPr>
            <a:lvl9pPr marL="12107022" indent="0" algn="ctr">
              <a:buNone/>
              <a:defRPr sz="529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54632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7967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60020" y="2278397"/>
            <a:ext cx="6526381" cy="3626613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80877" y="2278397"/>
            <a:ext cx="19200803" cy="3626613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61591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84735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5112" y="10668854"/>
            <a:ext cx="26105525" cy="17801211"/>
          </a:xfrm>
        </p:spPr>
        <p:txBody>
          <a:bodyPr anchor="b"/>
          <a:lstStyle>
            <a:lvl1pPr>
              <a:defRPr sz="198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5112" y="28638472"/>
            <a:ext cx="26105525" cy="9361236"/>
          </a:xfrm>
        </p:spPr>
        <p:txBody>
          <a:bodyPr/>
          <a:lstStyle>
            <a:lvl1pPr marL="0" indent="0">
              <a:buNone/>
              <a:defRPr sz="7944">
                <a:solidFill>
                  <a:schemeClr val="tx1"/>
                </a:solidFill>
              </a:defRPr>
            </a:lvl1pPr>
            <a:lvl2pPr marL="1513378" indent="0">
              <a:buNone/>
              <a:defRPr sz="6620">
                <a:solidFill>
                  <a:schemeClr val="tx1">
                    <a:tint val="75000"/>
                  </a:schemeClr>
                </a:solidFill>
              </a:defRPr>
            </a:lvl2pPr>
            <a:lvl3pPr marL="3026755" indent="0">
              <a:buNone/>
              <a:defRPr sz="5958">
                <a:solidFill>
                  <a:schemeClr val="tx1">
                    <a:tint val="75000"/>
                  </a:schemeClr>
                </a:solidFill>
              </a:defRPr>
            </a:lvl3pPr>
            <a:lvl4pPr marL="4540133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4pPr>
            <a:lvl5pPr marL="6053511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5pPr>
            <a:lvl6pPr marL="7566889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6pPr>
            <a:lvl7pPr marL="9080266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7pPr>
            <a:lvl8pPr marL="10593644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8pPr>
            <a:lvl9pPr marL="12107022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47703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80875" y="11391985"/>
            <a:ext cx="12863592" cy="27152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322808" y="11391985"/>
            <a:ext cx="12863592" cy="27152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09985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278406"/>
            <a:ext cx="26105525" cy="82715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4821" y="10490535"/>
            <a:ext cx="12804474" cy="5141249"/>
          </a:xfrm>
        </p:spPr>
        <p:txBody>
          <a:bodyPr anchor="b"/>
          <a:lstStyle>
            <a:lvl1pPr marL="0" indent="0">
              <a:buNone/>
              <a:defRPr sz="7944" b="1"/>
            </a:lvl1pPr>
            <a:lvl2pPr marL="1513378" indent="0">
              <a:buNone/>
              <a:defRPr sz="6620" b="1"/>
            </a:lvl2pPr>
            <a:lvl3pPr marL="3026755" indent="0">
              <a:buNone/>
              <a:defRPr sz="5958" b="1"/>
            </a:lvl3pPr>
            <a:lvl4pPr marL="4540133" indent="0">
              <a:buNone/>
              <a:defRPr sz="5296" b="1"/>
            </a:lvl4pPr>
            <a:lvl5pPr marL="6053511" indent="0">
              <a:buNone/>
              <a:defRPr sz="5296" b="1"/>
            </a:lvl5pPr>
            <a:lvl6pPr marL="7566889" indent="0">
              <a:buNone/>
              <a:defRPr sz="5296" b="1"/>
            </a:lvl6pPr>
            <a:lvl7pPr marL="9080266" indent="0">
              <a:buNone/>
              <a:defRPr sz="5296" b="1"/>
            </a:lvl7pPr>
            <a:lvl8pPr marL="10593644" indent="0">
              <a:buNone/>
              <a:defRPr sz="5296" b="1"/>
            </a:lvl8pPr>
            <a:lvl9pPr marL="12107022" indent="0">
              <a:buNone/>
              <a:defRPr sz="52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4821" y="15631784"/>
            <a:ext cx="12804474" cy="2299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22810" y="10490535"/>
            <a:ext cx="12867534" cy="5141249"/>
          </a:xfrm>
        </p:spPr>
        <p:txBody>
          <a:bodyPr anchor="b"/>
          <a:lstStyle>
            <a:lvl1pPr marL="0" indent="0">
              <a:buNone/>
              <a:defRPr sz="7944" b="1"/>
            </a:lvl1pPr>
            <a:lvl2pPr marL="1513378" indent="0">
              <a:buNone/>
              <a:defRPr sz="6620" b="1"/>
            </a:lvl2pPr>
            <a:lvl3pPr marL="3026755" indent="0">
              <a:buNone/>
              <a:defRPr sz="5958" b="1"/>
            </a:lvl3pPr>
            <a:lvl4pPr marL="4540133" indent="0">
              <a:buNone/>
              <a:defRPr sz="5296" b="1"/>
            </a:lvl4pPr>
            <a:lvl5pPr marL="6053511" indent="0">
              <a:buNone/>
              <a:defRPr sz="5296" b="1"/>
            </a:lvl5pPr>
            <a:lvl6pPr marL="7566889" indent="0">
              <a:buNone/>
              <a:defRPr sz="5296" b="1"/>
            </a:lvl6pPr>
            <a:lvl7pPr marL="9080266" indent="0">
              <a:buNone/>
              <a:defRPr sz="5296" b="1"/>
            </a:lvl7pPr>
            <a:lvl8pPr marL="10593644" indent="0">
              <a:buNone/>
              <a:defRPr sz="5296" b="1"/>
            </a:lvl8pPr>
            <a:lvl9pPr marL="12107022" indent="0">
              <a:buNone/>
              <a:defRPr sz="52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22810" y="15631784"/>
            <a:ext cx="12867534" cy="2299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07187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88211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20799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852949"/>
            <a:ext cx="9761984" cy="9985322"/>
          </a:xfrm>
        </p:spPr>
        <p:txBody>
          <a:bodyPr anchor="b"/>
          <a:lstStyle>
            <a:lvl1pPr>
              <a:defRPr sz="105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67534" y="6161587"/>
            <a:ext cx="15322808" cy="30411646"/>
          </a:xfrm>
        </p:spPr>
        <p:txBody>
          <a:bodyPr/>
          <a:lstStyle>
            <a:lvl1pPr>
              <a:defRPr sz="10592"/>
            </a:lvl1pPr>
            <a:lvl2pPr>
              <a:defRPr sz="9268"/>
            </a:lvl2pPr>
            <a:lvl3pPr>
              <a:defRPr sz="7944"/>
            </a:lvl3pPr>
            <a:lvl4pPr>
              <a:defRPr sz="6620"/>
            </a:lvl4pPr>
            <a:lvl5pPr>
              <a:defRPr sz="6620"/>
            </a:lvl5pPr>
            <a:lvl6pPr>
              <a:defRPr sz="6620"/>
            </a:lvl6pPr>
            <a:lvl7pPr>
              <a:defRPr sz="6620"/>
            </a:lvl7pPr>
            <a:lvl8pPr>
              <a:defRPr sz="6620"/>
            </a:lvl8pPr>
            <a:lvl9pPr>
              <a:defRPr sz="66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4817" y="12838271"/>
            <a:ext cx="9761984" cy="23784486"/>
          </a:xfrm>
        </p:spPr>
        <p:txBody>
          <a:bodyPr/>
          <a:lstStyle>
            <a:lvl1pPr marL="0" indent="0">
              <a:buNone/>
              <a:defRPr sz="5296"/>
            </a:lvl1pPr>
            <a:lvl2pPr marL="1513378" indent="0">
              <a:buNone/>
              <a:defRPr sz="4634"/>
            </a:lvl2pPr>
            <a:lvl3pPr marL="3026755" indent="0">
              <a:buNone/>
              <a:defRPr sz="3972"/>
            </a:lvl3pPr>
            <a:lvl4pPr marL="4540133" indent="0">
              <a:buNone/>
              <a:defRPr sz="3310"/>
            </a:lvl4pPr>
            <a:lvl5pPr marL="6053511" indent="0">
              <a:buNone/>
              <a:defRPr sz="3310"/>
            </a:lvl5pPr>
            <a:lvl6pPr marL="7566889" indent="0">
              <a:buNone/>
              <a:defRPr sz="3310"/>
            </a:lvl6pPr>
            <a:lvl7pPr marL="9080266" indent="0">
              <a:buNone/>
              <a:defRPr sz="3310"/>
            </a:lvl7pPr>
            <a:lvl8pPr marL="10593644" indent="0">
              <a:buNone/>
              <a:defRPr sz="3310"/>
            </a:lvl8pPr>
            <a:lvl9pPr marL="12107022" indent="0">
              <a:buNone/>
              <a:defRPr sz="33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71599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852949"/>
            <a:ext cx="9761984" cy="9985322"/>
          </a:xfrm>
        </p:spPr>
        <p:txBody>
          <a:bodyPr anchor="b"/>
          <a:lstStyle>
            <a:lvl1pPr>
              <a:defRPr sz="105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67534" y="6161587"/>
            <a:ext cx="15322808" cy="30411646"/>
          </a:xfrm>
        </p:spPr>
        <p:txBody>
          <a:bodyPr anchor="t"/>
          <a:lstStyle>
            <a:lvl1pPr marL="0" indent="0">
              <a:buNone/>
              <a:defRPr sz="10592"/>
            </a:lvl1pPr>
            <a:lvl2pPr marL="1513378" indent="0">
              <a:buNone/>
              <a:defRPr sz="9268"/>
            </a:lvl2pPr>
            <a:lvl3pPr marL="3026755" indent="0">
              <a:buNone/>
              <a:defRPr sz="7944"/>
            </a:lvl3pPr>
            <a:lvl4pPr marL="4540133" indent="0">
              <a:buNone/>
              <a:defRPr sz="6620"/>
            </a:lvl4pPr>
            <a:lvl5pPr marL="6053511" indent="0">
              <a:buNone/>
              <a:defRPr sz="6620"/>
            </a:lvl5pPr>
            <a:lvl6pPr marL="7566889" indent="0">
              <a:buNone/>
              <a:defRPr sz="6620"/>
            </a:lvl6pPr>
            <a:lvl7pPr marL="9080266" indent="0">
              <a:buNone/>
              <a:defRPr sz="6620"/>
            </a:lvl7pPr>
            <a:lvl8pPr marL="10593644" indent="0">
              <a:buNone/>
              <a:defRPr sz="6620"/>
            </a:lvl8pPr>
            <a:lvl9pPr marL="12107022" indent="0">
              <a:buNone/>
              <a:defRPr sz="66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4817" y="12838271"/>
            <a:ext cx="9761984" cy="23784486"/>
          </a:xfrm>
        </p:spPr>
        <p:txBody>
          <a:bodyPr/>
          <a:lstStyle>
            <a:lvl1pPr marL="0" indent="0">
              <a:buNone/>
              <a:defRPr sz="5296"/>
            </a:lvl1pPr>
            <a:lvl2pPr marL="1513378" indent="0">
              <a:buNone/>
              <a:defRPr sz="4634"/>
            </a:lvl2pPr>
            <a:lvl3pPr marL="3026755" indent="0">
              <a:buNone/>
              <a:defRPr sz="3972"/>
            </a:lvl3pPr>
            <a:lvl4pPr marL="4540133" indent="0">
              <a:buNone/>
              <a:defRPr sz="3310"/>
            </a:lvl4pPr>
            <a:lvl5pPr marL="6053511" indent="0">
              <a:buNone/>
              <a:defRPr sz="3310"/>
            </a:lvl5pPr>
            <a:lvl6pPr marL="7566889" indent="0">
              <a:buNone/>
              <a:defRPr sz="3310"/>
            </a:lvl6pPr>
            <a:lvl7pPr marL="9080266" indent="0">
              <a:buNone/>
              <a:defRPr sz="3310"/>
            </a:lvl7pPr>
            <a:lvl8pPr marL="10593644" indent="0">
              <a:buNone/>
              <a:defRPr sz="3310"/>
            </a:lvl8pPr>
            <a:lvl9pPr marL="12107022" indent="0">
              <a:buNone/>
              <a:defRPr sz="33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601924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80875" y="2278406"/>
            <a:ext cx="26105525" cy="8271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0875" y="11391985"/>
            <a:ext cx="26105525" cy="271525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80875" y="39663928"/>
            <a:ext cx="6810137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87189-78F9-40DE-A9C4-0D2EF0B5A6F5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26035" y="39663928"/>
            <a:ext cx="10215205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76263" y="39663928"/>
            <a:ext cx="6810137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24274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026755" rtl="0" eaLnBrk="1" latinLnBrk="0" hangingPunct="1">
        <a:lnSpc>
          <a:spcPct val="90000"/>
        </a:lnSpc>
        <a:spcBef>
          <a:spcPct val="0"/>
        </a:spcBef>
        <a:buNone/>
        <a:defRPr sz="145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56689" indent="-756689" algn="l" defTabSz="3026755" rtl="0" eaLnBrk="1" latinLnBrk="0" hangingPunct="1">
        <a:lnSpc>
          <a:spcPct val="90000"/>
        </a:lnSpc>
        <a:spcBef>
          <a:spcPts val="3310"/>
        </a:spcBef>
        <a:buFont typeface="Arial" panose="020B0604020202020204" pitchFamily="34" charset="0"/>
        <a:buChar char="•"/>
        <a:defRPr sz="9268" kern="1200">
          <a:solidFill>
            <a:schemeClr val="tx1"/>
          </a:solidFill>
          <a:latin typeface="+mn-lt"/>
          <a:ea typeface="+mn-ea"/>
          <a:cs typeface="+mn-cs"/>
        </a:defRPr>
      </a:lvl1pPr>
      <a:lvl2pPr marL="2270067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7944" kern="1200">
          <a:solidFill>
            <a:schemeClr val="tx1"/>
          </a:solidFill>
          <a:latin typeface="+mn-lt"/>
          <a:ea typeface="+mn-ea"/>
          <a:cs typeface="+mn-cs"/>
        </a:defRPr>
      </a:lvl2pPr>
      <a:lvl3pPr marL="3783444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6620" kern="1200">
          <a:solidFill>
            <a:schemeClr val="tx1"/>
          </a:solidFill>
          <a:latin typeface="+mn-lt"/>
          <a:ea typeface="+mn-ea"/>
          <a:cs typeface="+mn-cs"/>
        </a:defRPr>
      </a:lvl3pPr>
      <a:lvl4pPr marL="5296822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4pPr>
      <a:lvl5pPr marL="6810200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5pPr>
      <a:lvl6pPr marL="8323577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6pPr>
      <a:lvl7pPr marL="9836955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7pPr>
      <a:lvl8pPr marL="11350333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8pPr>
      <a:lvl9pPr marL="12863711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1pPr>
      <a:lvl2pPr marL="1513378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2pPr>
      <a:lvl3pPr marL="3026755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3pPr>
      <a:lvl4pPr marL="4540133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4pPr>
      <a:lvl5pPr marL="6053511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5pPr>
      <a:lvl6pPr marL="7566889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6pPr>
      <a:lvl7pPr marL="9080266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7pPr>
      <a:lvl8pPr marL="10593644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8pPr>
      <a:lvl9pPr marL="12107022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4655FD5-781F-4E1C-AE35-F28268EFE1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457200"/>
            <a:ext cx="30267275" cy="33204150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90DF0F6B-A126-4537-B3B8-745981EF6F45}"/>
              </a:ext>
            </a:extLst>
          </p:cNvPr>
          <p:cNvSpPr txBox="1"/>
          <p:nvPr/>
        </p:nvSpPr>
        <p:spPr>
          <a:xfrm>
            <a:off x="2343150" y="33661350"/>
            <a:ext cx="26689050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4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zh-CN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Comparison of antibiotic resistance in </a:t>
            </a:r>
            <a:r>
              <a:rPr lang="en-US" altLang="zh-CN" sz="4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ureus</a:t>
            </a:r>
            <a:r>
              <a:rPr lang="en-US" altLang="zh-CN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trains from veterinarians, pets, medical device surfaces, environmental surfaces and airborne dust of various veterinary hospitals in Guangzhou, China. AMO, amoxicillin; OXA, oxacillin; PEN, penicillin; FOX, cefoxitin; GEN, gentamycin; DOX, doxycycline; TIG, tigecycline; FFC, florfenicol, ERY, erythromycin; RIF, rifampicin; VAN, vancomycin; CLI, clindamycin; TIA, tiamulin; CIP, ciprofloxacin; FOS, </a:t>
            </a:r>
            <a:r>
              <a:rPr lang="en-US" altLang="zh-CN" sz="4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sfomycin</a:t>
            </a:r>
            <a:r>
              <a:rPr lang="en-US" altLang="zh-CN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LZD, linezolid; TZD, tedizolid; SXT, trimethoprim-sulfamethoxazole.</a:t>
            </a:r>
            <a:endParaRPr lang="zh-CN" altLang="en-US" sz="4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7408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8</TotalTime>
  <Words>107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ie van Wyk</dc:creator>
  <cp:lastModifiedBy>林 陈</cp:lastModifiedBy>
  <cp:revision>10</cp:revision>
  <dcterms:created xsi:type="dcterms:W3CDTF">2019-08-20T07:00:48Z</dcterms:created>
  <dcterms:modified xsi:type="dcterms:W3CDTF">2019-12-19T14:05:28Z</dcterms:modified>
</cp:coreProperties>
</file>